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erena Dully" initials="VD" lastIdx="1" clrIdx="0">
    <p:extLst>
      <p:ext uri="{19B8F6BF-5375-455C-9EA6-DF929625EA0E}">
        <p15:presenceInfo xmlns:p15="http://schemas.microsoft.com/office/powerpoint/2012/main" userId="5b2c871d29d23df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74"/>
  </p:normalViewPr>
  <p:slideViewPr>
    <p:cSldViewPr snapToGrid="0" snapToObjects="1">
      <p:cViewPr varScale="1">
        <p:scale>
          <a:sx n="119" d="100"/>
          <a:sy n="119" d="100"/>
        </p:scale>
        <p:origin x="216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FB16A5-F0D1-924F-8EB5-40575F6055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43F9DE-4ACC-A448-A292-0A3210071A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2E20B9-2FA4-784D-8DD6-D4F3D2DD7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6783C0-EFC2-AA4A-B690-8CDDAC1BD5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189CB8-4FCF-244A-8C41-88D3D69A1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712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367D49-6287-134B-9C75-B94AAD5DD2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FA221C-F40F-DD44-A57E-3B4402B26A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61C436-B9BA-DB40-9819-5988D94C9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7FF86E-4834-B14B-ABAB-CA40BC564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FC3A7E-B2A7-B940-A999-083FCEBD0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840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986D00-9B59-D240-9FBC-0238B0CAA6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88957C-CE00-7C44-9BD6-6BE08BE604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061041-3950-AF49-9601-05F3406C9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7E9FC8-BB39-7B4F-A2BF-B8B08B7C2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F80A3B-C13D-604C-88F1-4AE36FADE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784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BB5399-73FF-C34F-8493-EE92CF1ED9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9C1D59-F4DE-2340-BD2A-37857734A5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00E737-E407-3F4F-9B3A-C230FFF60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BB5D8A-5426-334D-B2C8-B3017675A2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D640D-F9DC-1048-A0F9-4705FE855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787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0CFCD9-7DC9-E440-9A9F-6B00FA7FBA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2457ED-978F-1243-AC63-E652611556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5B03C9-D3CB-244F-B870-410A4D47B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0698EC-E705-B349-BD96-A45ADF641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DF7AA7-F377-B24A-BF5F-ADCFC325E4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016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92FC5-8BDC-CF45-B31D-1DB1ED75A0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7C0AB5-1B9C-9C45-A794-9D3EC41CF1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9EFEEE-4524-AF4B-A6BD-1FDA45FA3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ADF574-6799-2F4A-9BFA-9408DE9E1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6F5BA6-28DB-4C4E-A48E-345D5F3CD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48C760-E8C3-B842-A92E-05CC9DDB1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99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422FD5-317B-8B40-B563-8FEC23E08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394C48-3FFE-6B4B-9E1B-C7F86DFCE6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D046F7-D53E-184F-B2F9-C2FB60CE4D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A77373-C5FE-A44C-8BDD-B59151D378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BFE4A5-C8F8-B244-8851-B40A5285B0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2AE70C4-8183-A04D-9BFF-DE47703CF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A97044-D232-6542-9D5D-9861B3134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FF28B4-2C2C-914D-842B-D35649F37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341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680DB-DFC4-BB4C-B82D-976A494073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655819-155E-8741-88FA-BC957415A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38064EE-4C15-3945-86F0-04CD6485E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33E6345-481A-B448-B2D1-58DBF5AC6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114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30B13C1-4A2C-8D4D-BF7C-8130B7864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10FC93-E820-F544-B7A8-3ECD6292F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21A0487-E45D-6D46-9215-D7CA2025A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574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9F449-0D81-9549-9163-6E8336E608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5736E1-058A-6D4C-9BC3-9C6B2EFF08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8A05CF-5BE7-3649-8CB8-BAA1B5C76B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6E7862-7DB2-5146-9361-8FF075511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3356F5-8DDF-424B-B915-733D17E216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8CF977-B28F-A340-9A99-0251CABB5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678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71EC2-DAF2-DA4D-A687-DDCECA62B0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588CC7-BAD5-8E44-BFCE-1151407DE1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378B7C-68AC-CF45-A2AD-4F1B4ECA77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64D0B5-677A-9E4A-96A4-60DB0B5BC8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3B911B-68E0-444F-878A-1AEEEFDA4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969325-498D-9645-AF17-40F6950F0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170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A1A90F-2ACB-9941-B259-68A7061CE4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79744E-E968-F74B-8776-0ED881663F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0B20BA-2F2E-894F-9476-ADF756C8E5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D6554D-EAD0-2449-BDDE-E0F0807EB942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6AD723-71CF-4E49-B7FA-261AE0AEEB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13ED73-ACA7-CF4E-9657-133B4453E9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011E11-BE0C-9941-81FD-F3D5D21184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11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2B7D9C3D-8E32-4B46-852B-AAE5EA3484B3}"/>
              </a:ext>
            </a:extLst>
          </p:cNvPr>
          <p:cNvSpPr txBox="1"/>
          <p:nvPr/>
        </p:nvSpPr>
        <p:spPr>
          <a:xfrm>
            <a:off x="0" y="11216"/>
            <a:ext cx="112491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/>
              <a:t>Supplementary file 4</a:t>
            </a:r>
            <a:r>
              <a:rPr lang="en-US" sz="1200" dirty="0"/>
              <a:t>: NMDS of bacterial community ASVs of the </a:t>
            </a:r>
            <a:r>
              <a:rPr lang="en-US" sz="1200" dirty="0" err="1"/>
              <a:t>ScoSa</a:t>
            </a:r>
            <a:r>
              <a:rPr lang="en-US" sz="1200" dirty="0"/>
              <a:t> dataset. Confidence intervals are for classes “salmon production phase” and “distance”. At different CI-thresholds (95%-70%), salmon production phase classes are substantially better separated than distance classes, corroborating well with the lower number of observations in a sample required to achieve targeted RF prediction performance (50 sequences for salmon production phase prediction versus 5000 sequences for distance prediction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54C1EFF-D53C-BE42-96CE-A325CEAF72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12261" y="788212"/>
            <a:ext cx="4770699" cy="597374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1D76CBB-996D-7C4C-8534-5BB03C2476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891" y="849633"/>
            <a:ext cx="5033529" cy="59737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259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1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rsten Stoeck</dc:creator>
  <cp:lastModifiedBy>stoeck@rhrk.uni-kl.de</cp:lastModifiedBy>
  <cp:revision>8</cp:revision>
  <dcterms:created xsi:type="dcterms:W3CDTF">2020-12-15T16:24:41Z</dcterms:created>
  <dcterms:modified xsi:type="dcterms:W3CDTF">2021-03-30T09:53:26Z</dcterms:modified>
</cp:coreProperties>
</file>